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83" d="100"/>
          <a:sy n="83" d="100"/>
        </p:scale>
        <p:origin x="45" y="5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ris\AppData\Local\Microsoft\Windows\INetCache\IE\0CM79U8J\NC%2520and%2520MB%2520Scan%2520Number%2520on%2520Threshold%2520Study%5b1%5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ris\AppData\Local\Microsoft\Windows\INetCache\IE\0CM79U8J\NC%2520and%2520MB%2520Scan%2520Number%2520on%2520Threshold%2520Study%5b1%5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ris\AppData\Local\Microsoft\Windows\INetCache\IE\0CM79U8J\NC%2520and%2520MB%2520Scan%2520Number%2520on%2520Threshold%2520Study%5b1%5d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ris\AppData\Local\Microsoft\Windows\INetCache\IE\0CM79U8J\NC%2520and%2520MB%2520Scan%2520Number%2520on%2520Threshold%2520Study%5b1%5d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Microbubbles!$Y$13</c:f>
              <c:strCache>
                <c:ptCount val="1"/>
                <c:pt idx="0">
                  <c:v>1x108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icrobubbles!$Z$21:$AE$21</c:f>
                <c:numCache>
                  <c:formatCode>General</c:formatCode>
                  <c:ptCount val="6"/>
                  <c:pt idx="0">
                    <c:v>0.14834651660408321</c:v>
                  </c:pt>
                  <c:pt idx="1">
                    <c:v>8.5033163996070762</c:v>
                  </c:pt>
                  <c:pt idx="2">
                    <c:v>3.2294697593225643</c:v>
                  </c:pt>
                  <c:pt idx="3">
                    <c:v>4.0958888902104835</c:v>
                  </c:pt>
                  <c:pt idx="4">
                    <c:v>1.968338823164409</c:v>
                  </c:pt>
                  <c:pt idx="5">
                    <c:v>1.1315974456020743</c:v>
                  </c:pt>
                </c:numCache>
              </c:numRef>
            </c:plus>
            <c:minus>
              <c:numRef>
                <c:f>Microbubbles!$Z$21:$AE$21</c:f>
                <c:numCache>
                  <c:formatCode>General</c:formatCode>
                  <c:ptCount val="6"/>
                  <c:pt idx="0">
                    <c:v>0.14834651660408321</c:v>
                  </c:pt>
                  <c:pt idx="1">
                    <c:v>8.5033163996070762</c:v>
                  </c:pt>
                  <c:pt idx="2">
                    <c:v>3.2294697593225643</c:v>
                  </c:pt>
                  <c:pt idx="3">
                    <c:v>4.0958888902104835</c:v>
                  </c:pt>
                  <c:pt idx="4">
                    <c:v>1.968338823164409</c:v>
                  </c:pt>
                  <c:pt idx="5">
                    <c:v>1.131597445602074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Microbubbles!$Z$6:$AE$6</c:f>
              <c:strCache>
                <c:ptCount val="6"/>
                <c:pt idx="0">
                  <c:v>Initial</c:v>
                </c:pt>
                <c:pt idx="1">
                  <c:v>1 Scan</c:v>
                </c:pt>
                <c:pt idx="2">
                  <c:v>2 Scans</c:v>
                </c:pt>
                <c:pt idx="3">
                  <c:v>4 Scans</c:v>
                </c:pt>
                <c:pt idx="4">
                  <c:v>6 Scans</c:v>
                </c:pt>
                <c:pt idx="5">
                  <c:v>Control</c:v>
                </c:pt>
              </c:strCache>
            </c:strRef>
          </c:cat>
          <c:val>
            <c:numRef>
              <c:f>Microbubbles!$Z$19:$AE$19</c:f>
              <c:numCache>
                <c:formatCode>General</c:formatCode>
                <c:ptCount val="6"/>
                <c:pt idx="0">
                  <c:v>5.8256258399999998</c:v>
                </c:pt>
                <c:pt idx="1">
                  <c:v>15.42071821333333</c:v>
                </c:pt>
                <c:pt idx="2">
                  <c:v>17.001727026666664</c:v>
                </c:pt>
                <c:pt idx="3">
                  <c:v>18.93944377</c:v>
                </c:pt>
                <c:pt idx="4">
                  <c:v>21.996909466666665</c:v>
                </c:pt>
                <c:pt idx="5">
                  <c:v>22.56366475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14-41E4-A2A4-5267E5277A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370802568"/>
        <c:axId val="1370804864"/>
      </c:barChart>
      <c:catAx>
        <c:axId val="1370802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70804864"/>
        <c:crosses val="autoZero"/>
        <c:auto val="1"/>
        <c:lblAlgn val="ctr"/>
        <c:lblOffset val="100"/>
        <c:noMultiLvlLbl val="0"/>
      </c:catAx>
      <c:valAx>
        <c:axId val="13708048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100"/>
                  <a:t>Cavitation Pressure (MPa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708025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742508748906385"/>
          <c:y val="0.90711103820355787"/>
          <c:w val="0.43320061470449384"/>
          <c:h val="6.63202749035978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Nanocones!$AH$11</c:f>
              <c:strCache>
                <c:ptCount val="1"/>
                <c:pt idx="0">
                  <c:v>1x10^-5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Nanocones!$AQ$19:$AV$19</c:f>
                <c:numCache>
                  <c:formatCode>General</c:formatCode>
                  <c:ptCount val="6"/>
                  <c:pt idx="0">
                    <c:v>0.34553364908631745</c:v>
                  </c:pt>
                  <c:pt idx="1">
                    <c:v>3.2783176379203023</c:v>
                  </c:pt>
                  <c:pt idx="2">
                    <c:v>3.8804264008563889</c:v>
                  </c:pt>
                  <c:pt idx="3">
                    <c:v>1.2391657666846216</c:v>
                  </c:pt>
                  <c:pt idx="4">
                    <c:v>0.9139922363313947</c:v>
                  </c:pt>
                  <c:pt idx="5">
                    <c:v>0.14831790037065062</c:v>
                  </c:pt>
                </c:numCache>
              </c:numRef>
            </c:plus>
            <c:minus>
              <c:numRef>
                <c:f>Nanocones!$AQ$19:$AV$19</c:f>
                <c:numCache>
                  <c:formatCode>General</c:formatCode>
                  <c:ptCount val="6"/>
                  <c:pt idx="0">
                    <c:v>0.34553364908631745</c:v>
                  </c:pt>
                  <c:pt idx="1">
                    <c:v>3.2783176379203023</c:v>
                  </c:pt>
                  <c:pt idx="2">
                    <c:v>3.8804264008563889</c:v>
                  </c:pt>
                  <c:pt idx="3">
                    <c:v>1.2391657666846216</c:v>
                  </c:pt>
                  <c:pt idx="4">
                    <c:v>0.9139922363313947</c:v>
                  </c:pt>
                  <c:pt idx="5">
                    <c:v>0.1483179003706506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Nanocones!$AI$4:$AM$4</c:f>
              <c:strCache>
                <c:ptCount val="5"/>
                <c:pt idx="0">
                  <c:v>Initial</c:v>
                </c:pt>
                <c:pt idx="1">
                  <c:v>1 Scan</c:v>
                </c:pt>
                <c:pt idx="2">
                  <c:v>2 Scans</c:v>
                </c:pt>
                <c:pt idx="3">
                  <c:v>4 Scans</c:v>
                </c:pt>
                <c:pt idx="4">
                  <c:v>Control</c:v>
                </c:pt>
              </c:strCache>
            </c:strRef>
          </c:cat>
          <c:val>
            <c:numRef>
              <c:f>Nanocones!$AI$17:$AM$17</c:f>
              <c:numCache>
                <c:formatCode>General</c:formatCode>
                <c:ptCount val="5"/>
                <c:pt idx="0">
                  <c:v>11.262826650000001</c:v>
                </c:pt>
                <c:pt idx="1">
                  <c:v>17.225928156666665</c:v>
                </c:pt>
                <c:pt idx="2">
                  <c:v>20.33526045</c:v>
                </c:pt>
                <c:pt idx="3">
                  <c:v>22.10473344</c:v>
                </c:pt>
                <c:pt idx="4">
                  <c:v>22.56366475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55-4763-B543-6921B2DFC5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370802568"/>
        <c:axId val="1370804864"/>
      </c:barChart>
      <c:catAx>
        <c:axId val="1370802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70804864"/>
        <c:crosses val="autoZero"/>
        <c:auto val="1"/>
        <c:lblAlgn val="ctr"/>
        <c:lblOffset val="100"/>
        <c:noMultiLvlLbl val="0"/>
      </c:catAx>
      <c:valAx>
        <c:axId val="13708048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100"/>
                  <a:t>Cavitation Pressure (MPa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708025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4612095363079616"/>
          <c:y val="0.90711103820355787"/>
          <c:w val="0.49185763605275484"/>
          <c:h val="6.63202749035978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icrobubbles!$Y$4</c:f>
              <c:strCache>
                <c:ptCount val="1"/>
                <c:pt idx="0">
                  <c:v>1x109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icrobubbles!$Z$12:$AF$12</c:f>
                <c:numCache>
                  <c:formatCode>General</c:formatCode>
                  <c:ptCount val="7"/>
                  <c:pt idx="0">
                    <c:v>0.28887115475770159</c:v>
                  </c:pt>
                  <c:pt idx="1">
                    <c:v>5.3642799965406383</c:v>
                  </c:pt>
                  <c:pt idx="2">
                    <c:v>3.5323863759561775</c:v>
                  </c:pt>
                  <c:pt idx="3">
                    <c:v>5.6355579347506746</c:v>
                  </c:pt>
                  <c:pt idx="4">
                    <c:v>7.3884146337779759</c:v>
                  </c:pt>
                  <c:pt idx="5">
                    <c:v>1.1315974456020743</c:v>
                  </c:pt>
                  <c:pt idx="6">
                    <c:v>0.71593330700857982</c:v>
                  </c:pt>
                </c:numCache>
              </c:numRef>
            </c:plus>
            <c:minus>
              <c:numRef>
                <c:f>Microbubbles!$Z$12:$AF$12</c:f>
                <c:numCache>
                  <c:formatCode>General</c:formatCode>
                  <c:ptCount val="7"/>
                  <c:pt idx="0">
                    <c:v>0.28887115475770159</c:v>
                  </c:pt>
                  <c:pt idx="1">
                    <c:v>5.3642799965406383</c:v>
                  </c:pt>
                  <c:pt idx="2">
                    <c:v>3.5323863759561775</c:v>
                  </c:pt>
                  <c:pt idx="3">
                    <c:v>5.6355579347506746</c:v>
                  </c:pt>
                  <c:pt idx="4">
                    <c:v>7.3884146337779759</c:v>
                  </c:pt>
                  <c:pt idx="5">
                    <c:v>1.1315974456020743</c:v>
                  </c:pt>
                  <c:pt idx="6">
                    <c:v>0.7159333070085798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Microbubbles!$Z$6:$AE$6</c:f>
              <c:strCache>
                <c:ptCount val="6"/>
                <c:pt idx="0">
                  <c:v>Initial</c:v>
                </c:pt>
                <c:pt idx="1">
                  <c:v>1 Scan</c:v>
                </c:pt>
                <c:pt idx="2">
                  <c:v>2 Scans</c:v>
                </c:pt>
                <c:pt idx="3">
                  <c:v>4 Scans</c:v>
                </c:pt>
                <c:pt idx="4">
                  <c:v>6 Scans</c:v>
                </c:pt>
                <c:pt idx="5">
                  <c:v>Control</c:v>
                </c:pt>
              </c:strCache>
            </c:strRef>
          </c:cat>
          <c:val>
            <c:numRef>
              <c:f>Microbubbles!$Z$10:$AE$10</c:f>
              <c:numCache>
                <c:formatCode>General</c:formatCode>
                <c:ptCount val="6"/>
                <c:pt idx="0">
                  <c:v>5.2296399999999998</c:v>
                </c:pt>
                <c:pt idx="1">
                  <c:v>10.401425816666665</c:v>
                </c:pt>
                <c:pt idx="2">
                  <c:v>13.042085269999999</c:v>
                </c:pt>
                <c:pt idx="3">
                  <c:v>14.881499549999999</c:v>
                </c:pt>
                <c:pt idx="4">
                  <c:v>17.728495949999999</c:v>
                </c:pt>
                <c:pt idx="5">
                  <c:v>22.56366475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AFF-4419-903E-00D251C72A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370802568"/>
        <c:axId val="1370804864"/>
      </c:barChart>
      <c:catAx>
        <c:axId val="1370802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70804864"/>
        <c:crosses val="autoZero"/>
        <c:auto val="1"/>
        <c:lblAlgn val="ctr"/>
        <c:lblOffset val="100"/>
        <c:noMultiLvlLbl val="0"/>
      </c:catAx>
      <c:valAx>
        <c:axId val="13708048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100"/>
                  <a:t>Cavitation Pressure (MPa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708025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742508748906387"/>
          <c:y val="0.90711103820355787"/>
          <c:w val="0.43320061470449384"/>
          <c:h val="6.63202749035978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Nanocones!$AH$2</c:f>
              <c:strCache>
                <c:ptCount val="1"/>
                <c:pt idx="0">
                  <c:v>1x10^-4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Nanocones!$AI$19:$AN$19</c:f>
                <c:numCache>
                  <c:formatCode>General</c:formatCode>
                  <c:ptCount val="6"/>
                  <c:pt idx="0">
                    <c:v>0.34553364908631745</c:v>
                  </c:pt>
                  <c:pt idx="1">
                    <c:v>3.2783176379203023</c:v>
                  </c:pt>
                  <c:pt idx="2">
                    <c:v>1.6345471223646002</c:v>
                  </c:pt>
                  <c:pt idx="3">
                    <c:v>0.23904353095082834</c:v>
                  </c:pt>
                  <c:pt idx="4">
                    <c:v>1.1315974456020743</c:v>
                  </c:pt>
                  <c:pt idx="5">
                    <c:v>0.71593330700857982</c:v>
                  </c:pt>
                </c:numCache>
              </c:numRef>
            </c:plus>
            <c:minus>
              <c:numRef>
                <c:f>Nanocones!$AI$19:$AN$19</c:f>
                <c:numCache>
                  <c:formatCode>General</c:formatCode>
                  <c:ptCount val="6"/>
                  <c:pt idx="0">
                    <c:v>0.34553364908631745</c:v>
                  </c:pt>
                  <c:pt idx="1">
                    <c:v>3.2783176379203023</c:v>
                  </c:pt>
                  <c:pt idx="2">
                    <c:v>1.6345471223646002</c:v>
                  </c:pt>
                  <c:pt idx="3">
                    <c:v>0.23904353095082834</c:v>
                  </c:pt>
                  <c:pt idx="4">
                    <c:v>1.1315974456020743</c:v>
                  </c:pt>
                  <c:pt idx="5">
                    <c:v>0.7159333070085798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Nanocones!$AI$4:$AM$4</c:f>
              <c:strCache>
                <c:ptCount val="5"/>
                <c:pt idx="0">
                  <c:v>Initial</c:v>
                </c:pt>
                <c:pt idx="1">
                  <c:v>1 Scan</c:v>
                </c:pt>
                <c:pt idx="2">
                  <c:v>2 Scans</c:v>
                </c:pt>
                <c:pt idx="3">
                  <c:v>4 Scans</c:v>
                </c:pt>
                <c:pt idx="4">
                  <c:v>Control</c:v>
                </c:pt>
              </c:strCache>
            </c:strRef>
          </c:cat>
          <c:val>
            <c:numRef>
              <c:f>Nanocones!$AI$8:$AM$8</c:f>
              <c:numCache>
                <c:formatCode>General</c:formatCode>
                <c:ptCount val="5"/>
                <c:pt idx="0">
                  <c:v>10.19024183</c:v>
                </c:pt>
                <c:pt idx="1">
                  <c:v>10.693908200000001</c:v>
                </c:pt>
                <c:pt idx="2">
                  <c:v>20.140959136666666</c:v>
                </c:pt>
                <c:pt idx="3">
                  <c:v>21.569345439999996</c:v>
                </c:pt>
                <c:pt idx="4">
                  <c:v>22.56366475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3A-4AF3-8C4A-410DEEE0D2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370802568"/>
        <c:axId val="1370804864"/>
      </c:barChart>
      <c:catAx>
        <c:axId val="1370802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70804864"/>
        <c:crosses val="autoZero"/>
        <c:auto val="1"/>
        <c:lblAlgn val="ctr"/>
        <c:lblOffset val="100"/>
        <c:noMultiLvlLbl val="0"/>
      </c:catAx>
      <c:valAx>
        <c:axId val="13708048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100"/>
                  <a:t>Cavitation Pressure (MPa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708025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4612095363079616"/>
          <c:y val="0.90711103820355787"/>
          <c:w val="0.49185763605275484"/>
          <c:h val="6.63202749035978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3D98F5-BCFE-ED1F-C226-E70695B594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54FA936-D133-14B5-9010-72999F6251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173209-7C3D-6168-FEB7-A8359CD938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05D9-E1B4-43CC-8500-314BFDB4E58A}" type="datetimeFigureOut">
              <a:rPr lang="en-US" smtClean="0"/>
              <a:t>6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8C6171-D3CE-C6C6-8C2E-9E1F843E15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21AB8B-912A-22AE-7989-728344F45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B1991-CF44-4294-AAAA-D6EEEB6D6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050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AB7583-2FA1-74FE-1B65-1E7884EDFE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FC34EB-0D0B-6051-8E65-B31C90A2DA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C5A1D3-B145-97E9-D05F-7E2BEB532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05D9-E1B4-43CC-8500-314BFDB4E58A}" type="datetimeFigureOut">
              <a:rPr lang="en-US" smtClean="0"/>
              <a:t>6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2D8796-0071-236D-539F-4B0923D4E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31389A-FE22-F86F-AA5E-60ED4A391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B1991-CF44-4294-AAAA-D6EEEB6D6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19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08F120-16ED-E685-5680-18E6A57DFE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9F5C85-5C61-1B6C-7B6A-80B4E6AE0A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C1372A-7786-B09C-9D40-4E52A8E732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05D9-E1B4-43CC-8500-314BFDB4E58A}" type="datetimeFigureOut">
              <a:rPr lang="en-US" smtClean="0"/>
              <a:t>6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AF783E-F98C-3D99-6EFE-6EBE46D32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8AB3CE-6605-0E44-D5A6-95176D514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B1991-CF44-4294-AAAA-D6EEEB6D6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1209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D368A8-103C-EA77-4BD0-7FD5B76271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68CB1A-9289-0108-3A00-B7854D13AC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00A287-1325-EEEE-6EEA-1E03E6EBC8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05D9-E1B4-43CC-8500-314BFDB4E58A}" type="datetimeFigureOut">
              <a:rPr lang="en-US" smtClean="0"/>
              <a:t>6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BF4604-8438-46F6-DE1C-1D98BB698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CBCA52-58AD-E1D5-4580-649B2314D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B1991-CF44-4294-AAAA-D6EEEB6D6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266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9C6E55-C66B-5DAE-1FD0-72A6DD05E5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1C56B2-70E1-CFB2-03E9-A688D998FA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9D469E-6B76-C9EA-D498-7FF0CBF9A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05D9-E1B4-43CC-8500-314BFDB4E58A}" type="datetimeFigureOut">
              <a:rPr lang="en-US" smtClean="0"/>
              <a:t>6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EDC6E8-E7DB-8BD4-64B2-B577A29AAB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8A0614-2E82-00BA-9625-A01B75617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B1991-CF44-4294-AAAA-D6EEEB6D6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158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1CCE07-D4AF-1376-9F43-0DB8D873D7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5219FE-A5E5-A1A5-92D2-6DDECFCA84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F794A7-95C3-D6F1-C879-0B392DC313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744AE3-F5AC-F0F5-D643-076DFC95FE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05D9-E1B4-43CC-8500-314BFDB4E58A}" type="datetimeFigureOut">
              <a:rPr lang="en-US" smtClean="0"/>
              <a:t>6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701BE5-6BD3-5085-055C-E5783DC952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071928-9F9A-5655-2F4A-0409F4A13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B1991-CF44-4294-AAAA-D6EEEB6D6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626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1A629A-6169-827A-E0FD-B1EDC4078A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872860-DD21-60B1-F0B2-2899961DBF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F58249-5869-5909-122D-C7957C2C00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3077AD6-23FE-1B6E-BA8F-12A4E290BD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18300F-3697-1451-B478-6C078BD06B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AA8C1C5-E304-14FF-1001-C5ABD34EF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05D9-E1B4-43CC-8500-314BFDB4E58A}" type="datetimeFigureOut">
              <a:rPr lang="en-US" smtClean="0"/>
              <a:t>6/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79D58D9-B90D-29B5-EA1F-8406A2C4C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456D3E1-9BC8-62E6-991F-01174D8D3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B1991-CF44-4294-AAAA-D6EEEB6D6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9423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E7B993-6AF0-9FA7-FA44-0FA3E9AF91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2A8239-A5AA-4C64-04F5-AE425EBF4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05D9-E1B4-43CC-8500-314BFDB4E58A}" type="datetimeFigureOut">
              <a:rPr lang="en-US" smtClean="0"/>
              <a:t>6/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E7F2E0D-0848-F1BB-CF90-3E0F4CECB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680A76-41AE-DE7D-1DF7-3DDEBCB29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B1991-CF44-4294-AAAA-D6EEEB6D6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669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C0DC2C-471C-949F-3342-5C8FC9DA0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05D9-E1B4-43CC-8500-314BFDB4E58A}" type="datetimeFigureOut">
              <a:rPr lang="en-US" smtClean="0"/>
              <a:t>6/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B5C6A5-53A8-ED9F-4E6C-06AB3F14F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BAA82A-09C5-011B-A8BA-042E1392F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B1991-CF44-4294-AAAA-D6EEEB6D6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79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EF17C-7955-A413-5D3F-FC1301DD82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4D40C0-EEC0-24A3-9918-B50B6C87C5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6D2FA4-E932-C3D5-27B6-B78EFEF5B0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5D50AA-B5D9-73E7-BBD0-11CD5AEED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05D9-E1B4-43CC-8500-314BFDB4E58A}" type="datetimeFigureOut">
              <a:rPr lang="en-US" smtClean="0"/>
              <a:t>6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8E8972-E482-3D25-4FC9-6B5C209C6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EA2F64-35DD-1D53-6941-2853D0AE9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B1991-CF44-4294-AAAA-D6EEEB6D6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309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A7B881-61F9-8E08-1A86-4DC3FEA2DB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EE2A1B-985B-793D-87FA-F4D151A5ED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EBBB74-161E-F88D-1D71-2381BA316C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C3621D-1533-E62E-B0F6-EC521F320E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05D9-E1B4-43CC-8500-314BFDB4E58A}" type="datetimeFigureOut">
              <a:rPr lang="en-US" smtClean="0"/>
              <a:t>6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B24D47-6FEF-BA39-EA18-DC3F804737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D3F9CE-E953-B8F5-F991-8192FAF0F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B1991-CF44-4294-AAAA-D6EEEB6D6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738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7129A87-1037-E9D2-9528-61C4A973C8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2C8981-9E17-064D-AF8E-DEA050F50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6F78F4-F8B7-BAF0-A00E-9BD518B1CF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605D9-E1B4-43CC-8500-314BFDB4E58A}" type="datetimeFigureOut">
              <a:rPr lang="en-US" smtClean="0"/>
              <a:t>6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6E9861-3AB7-C3B1-C976-A27CC9C5D8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25A3C4-F243-A872-97E8-51CAC023BB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6B1991-CF44-4294-AAAA-D6EEEB6D6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505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325DC984-8896-D3B2-CB5A-9B682BE100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1622904"/>
              </p:ext>
            </p:extLst>
          </p:nvPr>
        </p:nvGraphicFramePr>
        <p:xfrm>
          <a:off x="2160884" y="789522"/>
          <a:ext cx="3657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9B440A7A-7F9E-685A-F38B-A68D03E564B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43059978"/>
              </p:ext>
            </p:extLst>
          </p:nvPr>
        </p:nvGraphicFramePr>
        <p:xfrm>
          <a:off x="5815352" y="789522"/>
          <a:ext cx="3657600" cy="2747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EB3F79F-20B3-7057-EDC1-81EA3E17520E}"/>
              </a:ext>
            </a:extLst>
          </p:cNvPr>
          <p:cNvSpPr txBox="1"/>
          <p:nvPr/>
        </p:nvSpPr>
        <p:spPr>
          <a:xfrm>
            <a:off x="2159717" y="420190"/>
            <a:ext cx="3657600" cy="36933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robubbl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731A3FE-396E-B26B-8592-F0F9326B6A78}"/>
              </a:ext>
            </a:extLst>
          </p:cNvPr>
          <p:cNvSpPr txBox="1"/>
          <p:nvPr/>
        </p:nvSpPr>
        <p:spPr>
          <a:xfrm>
            <a:off x="5815352" y="420335"/>
            <a:ext cx="3657600" cy="36933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Nanocones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EEFE375-8145-412F-672F-283F1FA25F6A}"/>
              </a:ext>
            </a:extLst>
          </p:cNvPr>
          <p:cNvSpPr/>
          <p:nvPr/>
        </p:nvSpPr>
        <p:spPr>
          <a:xfrm>
            <a:off x="2159717" y="3185250"/>
            <a:ext cx="347472" cy="347472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20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20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42B2718-400C-EA17-99B2-06795D0D32EC}"/>
              </a:ext>
            </a:extLst>
          </p:cNvPr>
          <p:cNvSpPr/>
          <p:nvPr/>
        </p:nvSpPr>
        <p:spPr>
          <a:xfrm>
            <a:off x="5815343" y="3182259"/>
            <a:ext cx="347472" cy="350463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2000" b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2000" b="1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B9B3A7A3-4815-9172-188E-74A1D44A7EC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0250160"/>
              </p:ext>
            </p:extLst>
          </p:nvPr>
        </p:nvGraphicFramePr>
        <p:xfrm>
          <a:off x="2159717" y="3532722"/>
          <a:ext cx="3657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B1A71C16-EA56-F4D2-001C-0FEB8F4AD78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6428438"/>
              </p:ext>
            </p:extLst>
          </p:nvPr>
        </p:nvGraphicFramePr>
        <p:xfrm>
          <a:off x="5817317" y="3531227"/>
          <a:ext cx="3657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C6909D48-76EF-B962-765E-EDAB8A1F6C45}"/>
              </a:ext>
            </a:extLst>
          </p:cNvPr>
          <p:cNvSpPr/>
          <p:nvPr/>
        </p:nvSpPr>
        <p:spPr>
          <a:xfrm>
            <a:off x="5817097" y="5927703"/>
            <a:ext cx="347472" cy="347472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en-US" sz="20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4E508C5-4ECE-6DA7-26EC-B19BBEB22550}"/>
              </a:ext>
            </a:extLst>
          </p:cNvPr>
          <p:cNvSpPr/>
          <p:nvPr/>
        </p:nvSpPr>
        <p:spPr>
          <a:xfrm>
            <a:off x="2160664" y="5928450"/>
            <a:ext cx="347472" cy="347472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en-US" sz="20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708DEFF-ED9A-C7BC-8664-F347B19DD0BA}"/>
              </a:ext>
            </a:extLst>
          </p:cNvPr>
          <p:cNvSpPr txBox="1"/>
          <p:nvPr/>
        </p:nvSpPr>
        <p:spPr>
          <a:xfrm>
            <a:off x="3461126" y="3231108"/>
            <a:ext cx="1531058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x10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ubbles / m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FF73136-5293-BC38-2ADC-0C1E4DDC9CA0}"/>
              </a:ext>
            </a:extLst>
          </p:cNvPr>
          <p:cNvSpPr txBox="1"/>
          <p:nvPr/>
        </p:nvSpPr>
        <p:spPr>
          <a:xfrm>
            <a:off x="3461126" y="5961897"/>
            <a:ext cx="1531058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x10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ubbles / m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1AA03DC-EF18-F558-26DD-45750E8E6569}"/>
              </a:ext>
            </a:extLst>
          </p:cNvPr>
          <p:cNvSpPr txBox="1"/>
          <p:nvPr/>
        </p:nvSpPr>
        <p:spPr>
          <a:xfrm>
            <a:off x="7105650" y="3220104"/>
            <a:ext cx="1828800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x10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7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H mL / mL wate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35670FE-7947-98A3-6BF6-0BB4CF8A3BFE}"/>
              </a:ext>
            </a:extLst>
          </p:cNvPr>
          <p:cNvSpPr txBox="1"/>
          <p:nvPr/>
        </p:nvSpPr>
        <p:spPr>
          <a:xfrm>
            <a:off x="7105650" y="5969780"/>
            <a:ext cx="1828800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x10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6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H mL / mL water</a:t>
            </a:r>
          </a:p>
        </p:txBody>
      </p:sp>
    </p:spTree>
    <p:extLst>
      <p:ext uri="{BB962C8B-B14F-4D97-AF65-F5344CB8AC3E}">
        <p14:creationId xmlns:p14="http://schemas.microsoft.com/office/powerpoint/2010/main" val="1426512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6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Childers</dc:creator>
  <cp:lastModifiedBy>Christopher Childers</cp:lastModifiedBy>
  <cp:revision>1</cp:revision>
  <dcterms:created xsi:type="dcterms:W3CDTF">2022-06-04T05:16:06Z</dcterms:created>
  <dcterms:modified xsi:type="dcterms:W3CDTF">2022-06-04T05:17:21Z</dcterms:modified>
</cp:coreProperties>
</file>